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1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0" autoAdjust="0"/>
    <p:restoredTop sz="94633"/>
  </p:normalViewPr>
  <p:slideViewPr>
    <p:cSldViewPr snapToGrid="0" snapToObjects="1">
      <p:cViewPr varScale="1">
        <p:scale>
          <a:sx n="80" d="100"/>
          <a:sy n="80" d="100"/>
        </p:scale>
        <p:origin x="2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3rd%20manuscript\Data%20for%203rd%20paper\200328OsCLC5and6_realtime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3rd%20manuscript\Data%20for%203rd%20paper\200328OsCLC5and6_realtime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F$2,Sheet1!$F$6)</c:f>
                <c:numCache>
                  <c:formatCode>General</c:formatCode>
                  <c:ptCount val="2"/>
                  <c:pt idx="0">
                    <c:v>0.15463197811644991</c:v>
                  </c:pt>
                  <c:pt idx="1">
                    <c:v>1.0774191161172233</c:v>
                  </c:pt>
                </c:numCache>
              </c:numRef>
            </c:plus>
            <c:minus>
              <c:numRef>
                <c:f>(Sheet1!$F$2,Sheet1!$F$6)</c:f>
                <c:numCache>
                  <c:formatCode>General</c:formatCode>
                  <c:ptCount val="2"/>
                  <c:pt idx="0">
                    <c:v>0.15463197811644991</c:v>
                  </c:pt>
                  <c:pt idx="1">
                    <c:v>1.07741911611722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:$H$2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(Sheet1!$E$2,Sheet1!$E$6)</c:f>
              <c:numCache>
                <c:formatCode>General</c:formatCode>
                <c:ptCount val="2"/>
                <c:pt idx="0">
                  <c:v>0.54463957655071094</c:v>
                </c:pt>
                <c:pt idx="1">
                  <c:v>1.7332604840294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77-AE45-AC83-0E8E64D7095E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F$18,Sheet1!$F$22)</c:f>
                <c:numCache>
                  <c:formatCode>General</c:formatCode>
                  <c:ptCount val="2"/>
                  <c:pt idx="0">
                    <c:v>6.8767410914561435E-3</c:v>
                  </c:pt>
                  <c:pt idx="1">
                    <c:v>6.434683935036583E-3</c:v>
                  </c:pt>
                </c:numCache>
              </c:numRef>
            </c:plus>
            <c:minus>
              <c:numRef>
                <c:f>(Sheet1!$F$18,Sheet1!$F$22)</c:f>
                <c:numCache>
                  <c:formatCode>General</c:formatCode>
                  <c:ptCount val="2"/>
                  <c:pt idx="0">
                    <c:v>6.8767410914561435E-3</c:v>
                  </c:pt>
                  <c:pt idx="1">
                    <c:v>6.43468393503658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:$H$2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(Sheet1!$E$18,Sheet1!$E$22)</c:f>
              <c:numCache>
                <c:formatCode>General</c:formatCode>
                <c:ptCount val="2"/>
                <c:pt idx="0">
                  <c:v>1.8400043536688674E-2</c:v>
                </c:pt>
                <c:pt idx="1">
                  <c:v>2.30601450657801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377-AE45-AC83-0E8E64D709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41161871"/>
        <c:axId val="677270399"/>
      </c:barChart>
      <c:catAx>
        <c:axId val="74116187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77270399"/>
        <c:crosses val="autoZero"/>
        <c:auto val="1"/>
        <c:lblAlgn val="ctr"/>
        <c:lblOffset val="100"/>
        <c:noMultiLvlLbl val="0"/>
      </c:catAx>
      <c:valAx>
        <c:axId val="677270399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411618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F$34,Sheet1!$F$38)</c:f>
                <c:numCache>
                  <c:formatCode>General</c:formatCode>
                  <c:ptCount val="2"/>
                  <c:pt idx="0">
                    <c:v>0.40553293578492089</c:v>
                  </c:pt>
                  <c:pt idx="1">
                    <c:v>1.5007001606523882</c:v>
                  </c:pt>
                </c:numCache>
              </c:numRef>
            </c:plus>
            <c:minus>
              <c:numRef>
                <c:f>(Sheet1!$F$34,Sheet1!$F$38)</c:f>
                <c:numCache>
                  <c:formatCode>General</c:formatCode>
                  <c:ptCount val="2"/>
                  <c:pt idx="0">
                    <c:v>0.40553293578492089</c:v>
                  </c:pt>
                  <c:pt idx="1">
                    <c:v>1.50070016065238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:$H$2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(Sheet1!$E$34,Sheet1!$E$38)</c:f>
              <c:numCache>
                <c:formatCode>General</c:formatCode>
                <c:ptCount val="2"/>
                <c:pt idx="0">
                  <c:v>1.5611740013693873</c:v>
                </c:pt>
                <c:pt idx="1">
                  <c:v>5.34267061592010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59-5A4F-B4A2-951535780B0D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F$50,Sheet1!$F$54)</c:f>
                <c:numCache>
                  <c:formatCode>General</c:formatCode>
                  <c:ptCount val="2"/>
                  <c:pt idx="0">
                    <c:v>0.34472282765873863</c:v>
                  </c:pt>
                  <c:pt idx="1">
                    <c:v>0.4969482338236953</c:v>
                  </c:pt>
                </c:numCache>
              </c:numRef>
            </c:plus>
            <c:minus>
              <c:numRef>
                <c:f>(Sheet1!$F$50,Sheet1!$F$54)</c:f>
                <c:numCache>
                  <c:formatCode>General</c:formatCode>
                  <c:ptCount val="2"/>
                  <c:pt idx="0">
                    <c:v>0.34472282765873863</c:v>
                  </c:pt>
                  <c:pt idx="1">
                    <c:v>0.49694823382369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:$H$2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(Sheet1!$E$50,Sheet1!$E$54)</c:f>
              <c:numCache>
                <c:formatCode>General</c:formatCode>
                <c:ptCount val="2"/>
                <c:pt idx="0">
                  <c:v>1.121563531727972</c:v>
                </c:pt>
                <c:pt idx="1">
                  <c:v>1.39000377960800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59-5A4F-B4A2-951535780B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40349679"/>
        <c:axId val="740994991"/>
      </c:barChart>
      <c:catAx>
        <c:axId val="7403496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40994991"/>
        <c:crosses val="autoZero"/>
        <c:auto val="1"/>
        <c:lblAlgn val="ctr"/>
        <c:lblOffset val="100"/>
        <c:noMultiLvlLbl val="0"/>
      </c:catAx>
      <c:valAx>
        <c:axId val="740994991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403496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 dirty="0"/>
              <a:t>OsNPF2;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4:$F$64</c:f>
                <c:numCache>
                  <c:formatCode>General</c:formatCode>
                  <c:ptCount val="4"/>
                  <c:pt idx="0">
                    <c:v>8.0711420092409072E-2</c:v>
                  </c:pt>
                  <c:pt idx="1">
                    <c:v>0.17808456168660752</c:v>
                  </c:pt>
                  <c:pt idx="2">
                    <c:v>0.51218041526182723</c:v>
                  </c:pt>
                  <c:pt idx="3">
                    <c:v>0.1301759493062285</c:v>
                  </c:pt>
                </c:numCache>
              </c:numRef>
            </c:plus>
            <c:minus>
              <c:numRef>
                <c:f>Sheet1!$C$64:$F$64</c:f>
                <c:numCache>
                  <c:formatCode>General</c:formatCode>
                  <c:ptCount val="4"/>
                  <c:pt idx="0">
                    <c:v>8.0711420092409072E-2</c:v>
                  </c:pt>
                  <c:pt idx="1">
                    <c:v>0.17808456168660752</c:v>
                  </c:pt>
                  <c:pt idx="2">
                    <c:v>0.51218041526182723</c:v>
                  </c:pt>
                  <c:pt idx="3">
                    <c:v>0.13017594930622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28:$P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C$39:$D$39</c:f>
              <c:numCache>
                <c:formatCode>General</c:formatCode>
                <c:ptCount val="2"/>
                <c:pt idx="0">
                  <c:v>1.7990000000000002</c:v>
                </c:pt>
                <c:pt idx="1">
                  <c:v>8.3513333333333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7B-FC49-8230-FCBABB387A1C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64:$R$64</c:f>
                <c:numCache>
                  <c:formatCode>General</c:formatCode>
                  <c:ptCount val="4"/>
                  <c:pt idx="0">
                    <c:v>0.44503046088005149</c:v>
                  </c:pt>
                  <c:pt idx="1">
                    <c:v>0.18116505672391051</c:v>
                  </c:pt>
                  <c:pt idx="2">
                    <c:v>0.51739733281106082</c:v>
                  </c:pt>
                  <c:pt idx="3">
                    <c:v>0.13275834353357141</c:v>
                  </c:pt>
                </c:numCache>
              </c:numRef>
            </c:plus>
            <c:minus>
              <c:numRef>
                <c:f>Sheet1!$O$64:$R$64</c:f>
                <c:numCache>
                  <c:formatCode>General</c:formatCode>
                  <c:ptCount val="4"/>
                  <c:pt idx="0">
                    <c:v>0.44503046088005149</c:v>
                  </c:pt>
                  <c:pt idx="1">
                    <c:v>0.18116505672391051</c:v>
                  </c:pt>
                  <c:pt idx="2">
                    <c:v>0.51739733281106082</c:v>
                  </c:pt>
                  <c:pt idx="3">
                    <c:v>0.132758343533571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28:$P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O$39:$P$39</c:f>
              <c:numCache>
                <c:formatCode>General</c:formatCode>
                <c:ptCount val="2"/>
                <c:pt idx="0">
                  <c:v>6.9913333333333334</c:v>
                </c:pt>
                <c:pt idx="1">
                  <c:v>7.66933333333333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07B-FC49-8230-FCBABB387A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21877760"/>
        <c:axId val="1021911600"/>
      </c:barChart>
      <c:catAx>
        <c:axId val="1021877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1911600"/>
        <c:crosses val="autoZero"/>
        <c:auto val="1"/>
        <c:lblAlgn val="ctr"/>
        <c:lblOffset val="100"/>
        <c:noMultiLvlLbl val="0"/>
      </c:catAx>
      <c:valAx>
        <c:axId val="102191160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1877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CC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5:$F$65</c:f>
                <c:numCache>
                  <c:formatCode>General</c:formatCode>
                  <c:ptCount val="4"/>
                  <c:pt idx="0">
                    <c:v>1.7173332039337425E-2</c:v>
                  </c:pt>
                  <c:pt idx="1">
                    <c:v>9.4386763431696288E-2</c:v>
                  </c:pt>
                  <c:pt idx="2">
                    <c:v>4.1137979208188361E-2</c:v>
                  </c:pt>
                  <c:pt idx="3">
                    <c:v>0.16458668772952886</c:v>
                  </c:pt>
                </c:numCache>
              </c:numRef>
            </c:plus>
            <c:minus>
              <c:numRef>
                <c:f>Sheet1!$C$65:$F$65</c:f>
                <c:numCache>
                  <c:formatCode>General</c:formatCode>
                  <c:ptCount val="4"/>
                  <c:pt idx="0">
                    <c:v>1.7173332039337425E-2</c:v>
                  </c:pt>
                  <c:pt idx="1">
                    <c:v>9.4386763431696288E-2</c:v>
                  </c:pt>
                  <c:pt idx="2">
                    <c:v>4.1137979208188361E-2</c:v>
                  </c:pt>
                  <c:pt idx="3">
                    <c:v>0.164586687729528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28:$P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C$40:$D$40</c:f>
              <c:numCache>
                <c:formatCode>General</c:formatCode>
                <c:ptCount val="2"/>
                <c:pt idx="0">
                  <c:v>0.36190000000000005</c:v>
                </c:pt>
                <c:pt idx="1">
                  <c:v>1.056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3D-774B-B682-3A08AC966258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65:$R$65</c:f>
                <c:numCache>
                  <c:formatCode>General</c:formatCode>
                  <c:ptCount val="4"/>
                  <c:pt idx="0">
                    <c:v>1.6554187117195189E-2</c:v>
                  </c:pt>
                  <c:pt idx="1">
                    <c:v>0.14174429245808937</c:v>
                  </c:pt>
                  <c:pt idx="2">
                    <c:v>2.3860706890897729E-2</c:v>
                  </c:pt>
                  <c:pt idx="3">
                    <c:v>0.24456491980658221</c:v>
                  </c:pt>
                </c:numCache>
              </c:numRef>
            </c:plus>
            <c:minus>
              <c:numRef>
                <c:f>Sheet1!$O$65:$R$65</c:f>
                <c:numCache>
                  <c:formatCode>General</c:formatCode>
                  <c:ptCount val="4"/>
                  <c:pt idx="0">
                    <c:v>1.6554187117195189E-2</c:v>
                  </c:pt>
                  <c:pt idx="1">
                    <c:v>0.14174429245808937</c:v>
                  </c:pt>
                  <c:pt idx="2">
                    <c:v>2.3860706890897729E-2</c:v>
                  </c:pt>
                  <c:pt idx="3">
                    <c:v>0.244564919806582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28:$P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O$40:$P$40</c:f>
              <c:numCache>
                <c:formatCode>General</c:formatCode>
                <c:ptCount val="2"/>
                <c:pt idx="0">
                  <c:v>0.92563333333333331</c:v>
                </c:pt>
                <c:pt idx="1">
                  <c:v>1.295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3D-774B-B682-3A08AC9662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565808"/>
        <c:axId val="1074568128"/>
      </c:barChart>
      <c:catAx>
        <c:axId val="1074565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568128"/>
        <c:crosses val="autoZero"/>
        <c:auto val="1"/>
        <c:lblAlgn val="ctr"/>
        <c:lblOffset val="100"/>
        <c:noMultiLvlLbl val="0"/>
      </c:catAx>
      <c:valAx>
        <c:axId val="107456812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565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6:$F$66</c:f>
                <c:numCache>
                  <c:formatCode>General</c:formatCode>
                  <c:ptCount val="4"/>
                  <c:pt idx="0">
                    <c:v>2.2966956940594082E-2</c:v>
                  </c:pt>
                  <c:pt idx="1">
                    <c:v>0.21994342706957926</c:v>
                  </c:pt>
                  <c:pt idx="2">
                    <c:v>7.5739319012283465E-2</c:v>
                  </c:pt>
                  <c:pt idx="3">
                    <c:v>0.26549659968527944</c:v>
                  </c:pt>
                </c:numCache>
              </c:numRef>
            </c:plus>
            <c:minus>
              <c:numRef>
                <c:f>Sheet1!$C$66:$F$66</c:f>
                <c:numCache>
                  <c:formatCode>General</c:formatCode>
                  <c:ptCount val="4"/>
                  <c:pt idx="0">
                    <c:v>2.2966956940594082E-2</c:v>
                  </c:pt>
                  <c:pt idx="1">
                    <c:v>0.21994342706957926</c:v>
                  </c:pt>
                  <c:pt idx="2">
                    <c:v>7.5739319012283465E-2</c:v>
                  </c:pt>
                  <c:pt idx="3">
                    <c:v>0.265496599685279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28:$P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C$41:$D$41</c:f>
              <c:numCache>
                <c:formatCode>General</c:formatCode>
                <c:ptCount val="2"/>
                <c:pt idx="0">
                  <c:v>0.21486666666666668</c:v>
                </c:pt>
                <c:pt idx="1">
                  <c:v>1.627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E3-C141-B0C4-EF08BB91B824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66:$R$66</c:f>
                <c:numCache>
                  <c:formatCode>General</c:formatCode>
                  <c:ptCount val="4"/>
                  <c:pt idx="0">
                    <c:v>0.1315003168563991</c:v>
                  </c:pt>
                  <c:pt idx="1">
                    <c:v>0.21930217610512764</c:v>
                  </c:pt>
                  <c:pt idx="2">
                    <c:v>0.18189954492643565</c:v>
                  </c:pt>
                  <c:pt idx="3">
                    <c:v>0.37336949229654148</c:v>
                  </c:pt>
                </c:numCache>
              </c:numRef>
            </c:plus>
            <c:minus>
              <c:numRef>
                <c:f>Sheet1!$O$66:$R$66</c:f>
                <c:numCache>
                  <c:formatCode>General</c:formatCode>
                  <c:ptCount val="4"/>
                  <c:pt idx="0">
                    <c:v>0.1315003168563991</c:v>
                  </c:pt>
                  <c:pt idx="1">
                    <c:v>0.21930217610512764</c:v>
                  </c:pt>
                  <c:pt idx="2">
                    <c:v>0.18189954492643565</c:v>
                  </c:pt>
                  <c:pt idx="3">
                    <c:v>0.373369492296541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28:$P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O$41:$P$41</c:f>
              <c:numCache>
                <c:formatCode>General</c:formatCode>
                <c:ptCount val="2"/>
                <c:pt idx="0">
                  <c:v>4.2749999999999995</c:v>
                </c:pt>
                <c:pt idx="1">
                  <c:v>3.456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7E3-C141-B0C4-EF08BB91B8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22204224"/>
        <c:axId val="1022206272"/>
      </c:barChart>
      <c:catAx>
        <c:axId val="1022204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2206272"/>
        <c:crosses val="autoZero"/>
        <c:auto val="1"/>
        <c:lblAlgn val="ctr"/>
        <c:lblOffset val="100"/>
        <c:noMultiLvlLbl val="0"/>
      </c:catAx>
      <c:valAx>
        <c:axId val="102220627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2204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CLC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7:$F$67</c:f>
                <c:numCache>
                  <c:formatCode>General</c:formatCode>
                  <c:ptCount val="4"/>
                  <c:pt idx="0">
                    <c:v>5.4233026018387635E-2</c:v>
                  </c:pt>
                  <c:pt idx="1">
                    <c:v>0.19930908436674663</c:v>
                  </c:pt>
                  <c:pt idx="2">
                    <c:v>0.13714995848016523</c:v>
                  </c:pt>
                  <c:pt idx="3">
                    <c:v>0.12978572083759191</c:v>
                  </c:pt>
                </c:numCache>
              </c:numRef>
            </c:plus>
            <c:minus>
              <c:numRef>
                <c:f>Sheet1!$C$67:$F$67</c:f>
                <c:numCache>
                  <c:formatCode>General</c:formatCode>
                  <c:ptCount val="4"/>
                  <c:pt idx="0">
                    <c:v>5.4233026018387635E-2</c:v>
                  </c:pt>
                  <c:pt idx="1">
                    <c:v>0.19930908436674663</c:v>
                  </c:pt>
                  <c:pt idx="2">
                    <c:v>0.13714995848016523</c:v>
                  </c:pt>
                  <c:pt idx="3">
                    <c:v>0.129785720837591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28:$D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C$42:$D$42</c:f>
              <c:numCache>
                <c:formatCode>General</c:formatCode>
                <c:ptCount val="2"/>
                <c:pt idx="0">
                  <c:v>0.23183333333333334</c:v>
                </c:pt>
                <c:pt idx="1">
                  <c:v>1.520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22-6E4A-B55C-415BFCEA1307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67:$R$67</c:f>
                <c:numCache>
                  <c:formatCode>General</c:formatCode>
                  <c:ptCount val="4"/>
                  <c:pt idx="0">
                    <c:v>6.5378385826917906E-2</c:v>
                  </c:pt>
                  <c:pt idx="1">
                    <c:v>9.0555691888104653E-2</c:v>
                  </c:pt>
                  <c:pt idx="2">
                    <c:v>0.1304160010632632</c:v>
                  </c:pt>
                  <c:pt idx="3">
                    <c:v>6.722350779303321E-2</c:v>
                  </c:pt>
                </c:numCache>
              </c:numRef>
            </c:plus>
            <c:minus>
              <c:numRef>
                <c:f>Sheet1!$O$67:$R$67</c:f>
                <c:numCache>
                  <c:formatCode>General</c:formatCode>
                  <c:ptCount val="4"/>
                  <c:pt idx="0">
                    <c:v>6.5378385826917906E-2</c:v>
                  </c:pt>
                  <c:pt idx="1">
                    <c:v>9.0555691888104653E-2</c:v>
                  </c:pt>
                  <c:pt idx="2">
                    <c:v>0.1304160010632632</c:v>
                  </c:pt>
                  <c:pt idx="3">
                    <c:v>6.7223507793033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28:$D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O$42:$P$42</c:f>
              <c:numCache>
                <c:formatCode>General</c:formatCode>
                <c:ptCount val="2"/>
                <c:pt idx="0">
                  <c:v>1.3539999999999999</c:v>
                </c:pt>
                <c:pt idx="1">
                  <c:v>1.689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922-6E4A-B55C-415BFCEA13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21903472"/>
        <c:axId val="1021905520"/>
      </c:barChart>
      <c:catAx>
        <c:axId val="1021903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1905520"/>
        <c:crosses val="autoZero"/>
        <c:auto val="1"/>
        <c:lblAlgn val="ctr"/>
        <c:lblOffset val="100"/>
        <c:noMultiLvlLbl val="0"/>
      </c:catAx>
      <c:valAx>
        <c:axId val="102190552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219034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SLAH7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71:$F$71</c:f>
                <c:numCache>
                  <c:formatCode>General</c:formatCode>
                  <c:ptCount val="4"/>
                  <c:pt idx="0">
                    <c:v>1.5237149048004718E-3</c:v>
                  </c:pt>
                  <c:pt idx="1">
                    <c:v>1.6458187763069312E-2</c:v>
                  </c:pt>
                  <c:pt idx="2">
                    <c:v>3.001205313425476E-3</c:v>
                  </c:pt>
                  <c:pt idx="3">
                    <c:v>0.10923444206537304</c:v>
                  </c:pt>
                </c:numCache>
              </c:numRef>
            </c:plus>
            <c:minus>
              <c:numRef>
                <c:f>Sheet1!$C$71:$F$71</c:f>
                <c:numCache>
                  <c:formatCode>General</c:formatCode>
                  <c:ptCount val="4"/>
                  <c:pt idx="0">
                    <c:v>1.5237149048004718E-3</c:v>
                  </c:pt>
                  <c:pt idx="1">
                    <c:v>1.6458187763069312E-2</c:v>
                  </c:pt>
                  <c:pt idx="2">
                    <c:v>3.001205313425476E-3</c:v>
                  </c:pt>
                  <c:pt idx="3">
                    <c:v>0.109234442065373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28:$D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C$46:$D$46</c:f>
              <c:numCache>
                <c:formatCode>General</c:formatCode>
                <c:ptCount val="2"/>
                <c:pt idx="0">
                  <c:v>1.2409333333333333E-2</c:v>
                </c:pt>
                <c:pt idx="1">
                  <c:v>5.058666666666666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8C-ED42-9EF2-5D81CD98D5A5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71:$R$71</c:f>
                <c:numCache>
                  <c:formatCode>General</c:formatCode>
                  <c:ptCount val="4"/>
                  <c:pt idx="0">
                    <c:v>1.3050988893992352E-2</c:v>
                  </c:pt>
                  <c:pt idx="1">
                    <c:v>1.8638937737972085E-3</c:v>
                  </c:pt>
                  <c:pt idx="2">
                    <c:v>3.2470672066411632E-2</c:v>
                  </c:pt>
                  <c:pt idx="3">
                    <c:v>3.6304682893533273E-2</c:v>
                  </c:pt>
                </c:numCache>
              </c:numRef>
            </c:plus>
            <c:minus>
              <c:numRef>
                <c:f>Sheet1!$O$71:$R$71</c:f>
                <c:numCache>
                  <c:formatCode>General</c:formatCode>
                  <c:ptCount val="4"/>
                  <c:pt idx="0">
                    <c:v>1.3050988893992352E-2</c:v>
                  </c:pt>
                  <c:pt idx="1">
                    <c:v>1.8638937737972085E-3</c:v>
                  </c:pt>
                  <c:pt idx="2">
                    <c:v>3.2470672066411632E-2</c:v>
                  </c:pt>
                  <c:pt idx="3">
                    <c:v>3.630468289353327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28:$D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O$46:$P$46</c:f>
              <c:numCache>
                <c:formatCode>General</c:formatCode>
                <c:ptCount val="2"/>
                <c:pt idx="0">
                  <c:v>5.6693333333333325E-2</c:v>
                </c:pt>
                <c:pt idx="1">
                  <c:v>1.31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58C-ED42-9EF2-5D81CD98D5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6545984"/>
        <c:axId val="1076548736"/>
      </c:barChart>
      <c:catAx>
        <c:axId val="1076545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548736"/>
        <c:crosses val="autoZero"/>
        <c:auto val="1"/>
        <c:lblAlgn val="ctr"/>
        <c:lblOffset val="100"/>
        <c:noMultiLvlLbl val="0"/>
      </c:catAx>
      <c:valAx>
        <c:axId val="107654873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545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SLAH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75:$F$75</c:f>
                <c:numCache>
                  <c:formatCode>General</c:formatCode>
                  <c:ptCount val="4"/>
                  <c:pt idx="0">
                    <c:v>1.0594805330915709E-2</c:v>
                  </c:pt>
                  <c:pt idx="1">
                    <c:v>4.0106455562387684E-2</c:v>
                  </c:pt>
                  <c:pt idx="2">
                    <c:v>8.3362661505816463E-2</c:v>
                  </c:pt>
                  <c:pt idx="3">
                    <c:v>0.14854741106237318</c:v>
                  </c:pt>
                </c:numCache>
              </c:numRef>
            </c:plus>
            <c:minus>
              <c:numRef>
                <c:f>Sheet1!$C$75:$F$75</c:f>
                <c:numCache>
                  <c:formatCode>General</c:formatCode>
                  <c:ptCount val="4"/>
                  <c:pt idx="0">
                    <c:v>1.0594805330915709E-2</c:v>
                  </c:pt>
                  <c:pt idx="1">
                    <c:v>4.0106455562387684E-2</c:v>
                  </c:pt>
                  <c:pt idx="2">
                    <c:v>8.3362661505816463E-2</c:v>
                  </c:pt>
                  <c:pt idx="3">
                    <c:v>0.148547411062373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28:$D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C$50:$D$50</c:f>
              <c:numCache>
                <c:formatCode>General</c:formatCode>
                <c:ptCount val="2"/>
                <c:pt idx="0">
                  <c:v>7.3209999999999997E-2</c:v>
                </c:pt>
                <c:pt idx="1">
                  <c:v>0.7084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56-1544-8D7A-E3714EF837BF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75:$R$75</c:f>
                <c:numCache>
                  <c:formatCode>General</c:formatCode>
                  <c:ptCount val="4"/>
                  <c:pt idx="0">
                    <c:v>3.6830747458249373E-2</c:v>
                  </c:pt>
                  <c:pt idx="1">
                    <c:v>7.659249310474224E-2</c:v>
                  </c:pt>
                  <c:pt idx="2">
                    <c:v>0.1804044807277988</c:v>
                  </c:pt>
                  <c:pt idx="3">
                    <c:v>0.22906344645097851</c:v>
                  </c:pt>
                </c:numCache>
              </c:numRef>
            </c:plus>
            <c:minus>
              <c:numRef>
                <c:f>Sheet1!$O$75:$R$75</c:f>
                <c:numCache>
                  <c:formatCode>General</c:formatCode>
                  <c:ptCount val="4"/>
                  <c:pt idx="0">
                    <c:v>3.6830747458249373E-2</c:v>
                  </c:pt>
                  <c:pt idx="1">
                    <c:v>7.659249310474224E-2</c:v>
                  </c:pt>
                  <c:pt idx="2">
                    <c:v>0.1804044807277988</c:v>
                  </c:pt>
                  <c:pt idx="3">
                    <c:v>0.229063446450978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C$28:$D$28</c:f>
              <c:strCache>
                <c:ptCount val="2"/>
                <c:pt idx="0">
                  <c:v>Sheath1</c:v>
                </c:pt>
                <c:pt idx="1">
                  <c:v>Sheath2</c:v>
                </c:pt>
              </c:strCache>
            </c:strRef>
          </c:cat>
          <c:val>
            <c:numRef>
              <c:f>Sheet1!$O$50:$P$50</c:f>
              <c:numCache>
                <c:formatCode>General</c:formatCode>
                <c:ptCount val="2"/>
                <c:pt idx="0">
                  <c:v>0.29216666666666663</c:v>
                </c:pt>
                <c:pt idx="1">
                  <c:v>0.917833333333333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56-1544-8D7A-E3714EF837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5419520"/>
        <c:axId val="1075421840"/>
      </c:barChart>
      <c:catAx>
        <c:axId val="1075419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5421840"/>
        <c:crosses val="autoZero"/>
        <c:auto val="1"/>
        <c:lblAlgn val="ctr"/>
        <c:lblOffset val="100"/>
        <c:noMultiLvlLbl val="0"/>
      </c:catAx>
      <c:valAx>
        <c:axId val="107542184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5419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9980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55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1143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142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5772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23528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953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500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63792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37358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1867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7373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CD4FB949-7B0B-3042-ABF4-EF5FB8CC27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6871092"/>
              </p:ext>
            </p:extLst>
          </p:nvPr>
        </p:nvGraphicFramePr>
        <p:xfrm>
          <a:off x="228349" y="2974039"/>
          <a:ext cx="1537223" cy="18365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AA56112-2D9D-574A-9049-7F9F3AE868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2758159"/>
              </p:ext>
            </p:extLst>
          </p:nvPr>
        </p:nvGraphicFramePr>
        <p:xfrm>
          <a:off x="1822533" y="2979237"/>
          <a:ext cx="1543431" cy="1831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0000000-0008-0000-0000-00000C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0158913"/>
              </p:ext>
            </p:extLst>
          </p:nvPr>
        </p:nvGraphicFramePr>
        <p:xfrm>
          <a:off x="228349" y="1091770"/>
          <a:ext cx="1537224" cy="1836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00000000-0008-0000-0000-00000D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4531406"/>
              </p:ext>
            </p:extLst>
          </p:nvPr>
        </p:nvGraphicFramePr>
        <p:xfrm>
          <a:off x="1828675" y="1091770"/>
          <a:ext cx="1537224" cy="1836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00000000-0008-0000-0000-00000E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6852884"/>
              </p:ext>
            </p:extLst>
          </p:nvPr>
        </p:nvGraphicFramePr>
        <p:xfrm>
          <a:off x="3429000" y="1089977"/>
          <a:ext cx="1537223" cy="1836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00000000-0008-0000-0000-00000F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7127548"/>
              </p:ext>
            </p:extLst>
          </p:nvPr>
        </p:nvGraphicFramePr>
        <p:xfrm>
          <a:off x="5029326" y="1089976"/>
          <a:ext cx="1537224" cy="1836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00000000-0008-0000-0000-00001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5708034"/>
              </p:ext>
            </p:extLst>
          </p:nvPr>
        </p:nvGraphicFramePr>
        <p:xfrm>
          <a:off x="5026254" y="2974039"/>
          <a:ext cx="1543431" cy="18313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00000000-0008-0000-0000-00001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8079985"/>
              </p:ext>
            </p:extLst>
          </p:nvPr>
        </p:nvGraphicFramePr>
        <p:xfrm>
          <a:off x="3441652" y="2974039"/>
          <a:ext cx="1524439" cy="18313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74A5F749-B728-044F-9D2B-FDF177BB068C}"/>
              </a:ext>
            </a:extLst>
          </p:cNvPr>
          <p:cNvSpPr txBox="1"/>
          <p:nvPr/>
        </p:nvSpPr>
        <p:spPr>
          <a:xfrm>
            <a:off x="228349" y="1089975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9E5A774-B0C7-E14B-BFD7-7159E39A2F6B}"/>
              </a:ext>
            </a:extLst>
          </p:cNvPr>
          <p:cNvSpPr txBox="1"/>
          <p:nvPr/>
        </p:nvSpPr>
        <p:spPr>
          <a:xfrm>
            <a:off x="1832577" y="1089975"/>
            <a:ext cx="28725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0C6FB6-E216-9549-B3BB-AAB44D7BE43D}"/>
              </a:ext>
            </a:extLst>
          </p:cNvPr>
          <p:cNvSpPr txBox="1"/>
          <p:nvPr/>
        </p:nvSpPr>
        <p:spPr>
          <a:xfrm>
            <a:off x="228349" y="2974039"/>
            <a:ext cx="27924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F6346AE-20A4-8B4D-BC7B-B0881D3D63E7}"/>
              </a:ext>
            </a:extLst>
          </p:cNvPr>
          <p:cNvSpPr txBox="1"/>
          <p:nvPr/>
        </p:nvSpPr>
        <p:spPr>
          <a:xfrm>
            <a:off x="3423397" y="1089975"/>
            <a:ext cx="28725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E4FB03C-4DCC-1C4B-B3F3-8CBEBD6ACAAF}"/>
              </a:ext>
            </a:extLst>
          </p:cNvPr>
          <p:cNvSpPr txBox="1"/>
          <p:nvPr/>
        </p:nvSpPr>
        <p:spPr>
          <a:xfrm>
            <a:off x="5037829" y="1089974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08CE540-2FDD-E646-9F85-C66A3DD0D28B}"/>
              </a:ext>
            </a:extLst>
          </p:cNvPr>
          <p:cNvSpPr txBox="1"/>
          <p:nvPr/>
        </p:nvSpPr>
        <p:spPr>
          <a:xfrm>
            <a:off x="1821912" y="2974039"/>
            <a:ext cx="269626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181F8F1-859D-1249-9B5E-1FFA889457F8}"/>
              </a:ext>
            </a:extLst>
          </p:cNvPr>
          <p:cNvSpPr txBox="1"/>
          <p:nvPr/>
        </p:nvSpPr>
        <p:spPr>
          <a:xfrm>
            <a:off x="3441652" y="2974038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B237FCC-2C5A-DC47-86C7-16882B776363}"/>
              </a:ext>
            </a:extLst>
          </p:cNvPr>
          <p:cNvSpPr txBox="1"/>
          <p:nvPr/>
        </p:nvSpPr>
        <p:spPr>
          <a:xfrm>
            <a:off x="5025597" y="2974038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3992CB9-0B3C-6B44-BA48-518C4EFDAA07}"/>
              </a:ext>
            </a:extLst>
          </p:cNvPr>
          <p:cNvSpPr txBox="1"/>
          <p:nvPr/>
        </p:nvSpPr>
        <p:spPr>
          <a:xfrm>
            <a:off x="764673" y="163718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345F9A6-D911-BB4C-9F3A-40EFB4E058E5}"/>
              </a:ext>
            </a:extLst>
          </p:cNvPr>
          <p:cNvSpPr txBox="1"/>
          <p:nvPr/>
        </p:nvSpPr>
        <p:spPr>
          <a:xfrm>
            <a:off x="2388401" y="193131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F7DA290-CA9C-9742-98E9-D2ECE076E110}"/>
              </a:ext>
            </a:extLst>
          </p:cNvPr>
          <p:cNvSpPr txBox="1"/>
          <p:nvPr/>
        </p:nvSpPr>
        <p:spPr>
          <a:xfrm>
            <a:off x="3919224" y="148190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E9BBE37-730C-F742-84A8-7588CE8F3F84}"/>
              </a:ext>
            </a:extLst>
          </p:cNvPr>
          <p:cNvSpPr txBox="1"/>
          <p:nvPr/>
        </p:nvSpPr>
        <p:spPr>
          <a:xfrm>
            <a:off x="4498308" y="163718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BB9B290-23D3-AE4D-983C-63ACF0B55D02}"/>
              </a:ext>
            </a:extLst>
          </p:cNvPr>
          <p:cNvSpPr txBox="1"/>
          <p:nvPr/>
        </p:nvSpPr>
        <p:spPr>
          <a:xfrm>
            <a:off x="5584394" y="166235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58BB3AF-EF9A-D748-98E0-2FD464772A2D}"/>
              </a:ext>
            </a:extLst>
          </p:cNvPr>
          <p:cNvSpPr txBox="1"/>
          <p:nvPr/>
        </p:nvSpPr>
        <p:spPr>
          <a:xfrm>
            <a:off x="5625188" y="335197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5403106-C8AB-684F-90B7-2B6A565424A9}"/>
              </a:ext>
            </a:extLst>
          </p:cNvPr>
          <p:cNvSpPr txBox="1"/>
          <p:nvPr/>
        </p:nvSpPr>
        <p:spPr>
          <a:xfrm>
            <a:off x="4515086" y="340909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FB34895-494E-4446-AC5F-724597186EDF}"/>
              </a:ext>
            </a:extLst>
          </p:cNvPr>
          <p:cNvSpPr txBox="1"/>
          <p:nvPr/>
        </p:nvSpPr>
        <p:spPr>
          <a:xfrm>
            <a:off x="3990730" y="401713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56430AD-5100-3E47-BEA0-805909E1D75E}"/>
              </a:ext>
            </a:extLst>
          </p:cNvPr>
          <p:cNvSpPr txBox="1"/>
          <p:nvPr/>
        </p:nvSpPr>
        <p:spPr>
          <a:xfrm>
            <a:off x="781451" y="431930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6592056-3A75-1E4C-99F0-1E5463D2DF7C}"/>
              </a:ext>
            </a:extLst>
          </p:cNvPr>
          <p:cNvSpPr txBox="1"/>
          <p:nvPr/>
        </p:nvSpPr>
        <p:spPr>
          <a:xfrm>
            <a:off x="2897114" y="406747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32429873-ACA1-2A4E-B4D0-6ED1B1EDE7E7}"/>
              </a:ext>
            </a:extLst>
          </p:cNvPr>
          <p:cNvGrpSpPr/>
          <p:nvPr/>
        </p:nvGrpSpPr>
        <p:grpSpPr>
          <a:xfrm>
            <a:off x="611809" y="5027922"/>
            <a:ext cx="1216866" cy="720333"/>
            <a:chOff x="0" y="16318"/>
            <a:chExt cx="666992" cy="392061"/>
          </a:xfrm>
        </p:grpSpPr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95B12D08-46BE-B246-A70D-2FBAC52F185F}"/>
                </a:ext>
              </a:extLst>
            </p:cNvPr>
            <p:cNvSpPr/>
            <p:nvPr/>
          </p:nvSpPr>
          <p:spPr>
            <a:xfrm>
              <a:off x="0" y="193948"/>
              <a:ext cx="132646" cy="12326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2600"/>
            </a:p>
          </p:txBody>
        </p:sp>
        <p:sp>
          <p:nvSpPr>
            <p:cNvPr id="35" name="TextBox 162">
              <a:extLst>
                <a:ext uri="{FF2B5EF4-FFF2-40B4-BE49-F238E27FC236}">
                  <a16:creationId xmlns:a16="http://schemas.microsoft.com/office/drawing/2014/main" id="{04EA31F0-78FB-A848-BE06-465CE48EA80C}"/>
                </a:ext>
              </a:extLst>
            </p:cNvPr>
            <p:cNvSpPr txBox="1"/>
            <p:nvPr/>
          </p:nvSpPr>
          <p:spPr>
            <a:xfrm>
              <a:off x="109302" y="16318"/>
              <a:ext cx="557690" cy="22436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Helvetica" pitchFamily="2" charset="0"/>
                  <a:cs typeface="Arial Unicode MS" panose="020B0604020202020204" pitchFamily="34" charset="-128"/>
                </a:rPr>
                <a:t>Control</a:t>
              </a:r>
              <a:r>
                <a:rPr lang="en-US" sz="1400" dirty="0">
                  <a:solidFill>
                    <a:srgbClr val="000000"/>
                  </a:solidFill>
                  <a:latin typeface="Helvetica" pitchFamily="2" charset="0"/>
                  <a:ea typeface="Helvetica" pitchFamily="2" charset="0"/>
                  <a:cs typeface="Helvetica" pitchFamily="2" charset="0"/>
                </a:rPr>
                <a:t> </a:t>
              </a:r>
              <a:endParaRPr lang="en-JP" sz="1400" dirty="0">
                <a:latin typeface="Calibri" panose="020F0502020204030204" pitchFamily="34" charset="0"/>
                <a:ea typeface="Yu Mincho" panose="02020400000000000000" pitchFamily="18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36" name="TextBox 163">
              <a:extLst>
                <a:ext uri="{FF2B5EF4-FFF2-40B4-BE49-F238E27FC236}">
                  <a16:creationId xmlns:a16="http://schemas.microsoft.com/office/drawing/2014/main" id="{07B58E95-3C0D-0A47-93DD-9647953AAC14}"/>
                </a:ext>
              </a:extLst>
            </p:cNvPr>
            <p:cNvSpPr txBox="1"/>
            <p:nvPr/>
          </p:nvSpPr>
          <p:spPr>
            <a:xfrm>
              <a:off x="119964" y="184018"/>
              <a:ext cx="427536" cy="22436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Helvetica" pitchFamily="2" charset="0"/>
                  <a:cs typeface="Arial Unicode MS" panose="020B0604020202020204" pitchFamily="34" charset="-128"/>
                </a:rPr>
                <a:t>NaCl </a:t>
              </a:r>
              <a:endParaRPr lang="en-JP" sz="1400" dirty="0">
                <a:latin typeface="Calibri" panose="020F0502020204030204" pitchFamily="34" charset="0"/>
                <a:ea typeface="Yu Mincho" panose="02020400000000000000" pitchFamily="18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C0302FF0-CE5C-CE45-81F8-A24E8CB98E68}"/>
                </a:ext>
              </a:extLst>
            </p:cNvPr>
            <p:cNvSpPr/>
            <p:nvPr/>
          </p:nvSpPr>
          <p:spPr>
            <a:xfrm>
              <a:off x="0" y="25283"/>
              <a:ext cx="132646" cy="1296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2600"/>
            </a:p>
          </p:txBody>
        </p:sp>
      </p:grpSp>
      <p:sp>
        <p:nvSpPr>
          <p:cNvPr id="38" name="テキスト ボックス 34">
            <a:extLst>
              <a:ext uri="{FF2B5EF4-FFF2-40B4-BE49-F238E27FC236}">
                <a16:creationId xmlns:a16="http://schemas.microsoft.com/office/drawing/2014/main" id="{666C390D-E6D5-0045-9ADE-2DA227340E9E}"/>
              </a:ext>
            </a:extLst>
          </p:cNvPr>
          <p:cNvSpPr txBox="1"/>
          <p:nvPr/>
        </p:nvSpPr>
        <p:spPr>
          <a:xfrm>
            <a:off x="572296" y="2648292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4">
            <a:extLst>
              <a:ext uri="{FF2B5EF4-FFF2-40B4-BE49-F238E27FC236}">
                <a16:creationId xmlns:a16="http://schemas.microsoft.com/office/drawing/2014/main" id="{010FD264-D8C9-074C-ACED-BDD48C147975}"/>
              </a:ext>
            </a:extLst>
          </p:cNvPr>
          <p:cNvSpPr txBox="1"/>
          <p:nvPr/>
        </p:nvSpPr>
        <p:spPr>
          <a:xfrm>
            <a:off x="2187565" y="2647418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4">
            <a:extLst>
              <a:ext uri="{FF2B5EF4-FFF2-40B4-BE49-F238E27FC236}">
                <a16:creationId xmlns:a16="http://schemas.microsoft.com/office/drawing/2014/main" id="{A0CE458A-ED82-624E-8D20-BF80C8E4A938}"/>
              </a:ext>
            </a:extLst>
          </p:cNvPr>
          <p:cNvSpPr txBox="1"/>
          <p:nvPr/>
        </p:nvSpPr>
        <p:spPr>
          <a:xfrm>
            <a:off x="3730033" y="2641321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34">
            <a:extLst>
              <a:ext uri="{FF2B5EF4-FFF2-40B4-BE49-F238E27FC236}">
                <a16:creationId xmlns:a16="http://schemas.microsoft.com/office/drawing/2014/main" id="{978A0B07-F40D-D846-A655-56FD48B27DB2}"/>
              </a:ext>
            </a:extLst>
          </p:cNvPr>
          <p:cNvSpPr txBox="1"/>
          <p:nvPr/>
        </p:nvSpPr>
        <p:spPr>
          <a:xfrm>
            <a:off x="5402350" y="2647418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34">
            <a:extLst>
              <a:ext uri="{FF2B5EF4-FFF2-40B4-BE49-F238E27FC236}">
                <a16:creationId xmlns:a16="http://schemas.microsoft.com/office/drawing/2014/main" id="{B59A550E-DA16-A24E-9E5A-A548F10C37B2}"/>
              </a:ext>
            </a:extLst>
          </p:cNvPr>
          <p:cNvSpPr txBox="1"/>
          <p:nvPr/>
        </p:nvSpPr>
        <p:spPr>
          <a:xfrm>
            <a:off x="572990" y="4521004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34">
            <a:extLst>
              <a:ext uri="{FF2B5EF4-FFF2-40B4-BE49-F238E27FC236}">
                <a16:creationId xmlns:a16="http://schemas.microsoft.com/office/drawing/2014/main" id="{D5D0AD3C-9AE4-A445-8DC0-0FD2E88306FE}"/>
              </a:ext>
            </a:extLst>
          </p:cNvPr>
          <p:cNvSpPr txBox="1"/>
          <p:nvPr/>
        </p:nvSpPr>
        <p:spPr>
          <a:xfrm>
            <a:off x="2119835" y="4521915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34">
            <a:extLst>
              <a:ext uri="{FF2B5EF4-FFF2-40B4-BE49-F238E27FC236}">
                <a16:creationId xmlns:a16="http://schemas.microsoft.com/office/drawing/2014/main" id="{77EB93ED-4DE7-204C-84B4-290D5EB57ADA}"/>
              </a:ext>
            </a:extLst>
          </p:cNvPr>
          <p:cNvSpPr txBox="1"/>
          <p:nvPr/>
        </p:nvSpPr>
        <p:spPr>
          <a:xfrm>
            <a:off x="3801891" y="4516696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34">
            <a:extLst>
              <a:ext uri="{FF2B5EF4-FFF2-40B4-BE49-F238E27FC236}">
                <a16:creationId xmlns:a16="http://schemas.microsoft.com/office/drawing/2014/main" id="{7D49E05B-DFC5-4940-925D-AF6FD81597E0}"/>
              </a:ext>
            </a:extLst>
          </p:cNvPr>
          <p:cNvSpPr txBox="1"/>
          <p:nvPr/>
        </p:nvSpPr>
        <p:spPr>
          <a:xfrm>
            <a:off x="5429696" y="4518175"/>
            <a:ext cx="116420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al        Middl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0284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3</TotalTime>
  <Words>44</Words>
  <Application>Microsoft Office PowerPoint</Application>
  <PresentationFormat>A4 210 x 297 mm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90</cp:revision>
  <cp:lastPrinted>2020-08-12T07:18:28Z</cp:lastPrinted>
  <dcterms:created xsi:type="dcterms:W3CDTF">2020-05-19T13:06:08Z</dcterms:created>
  <dcterms:modified xsi:type="dcterms:W3CDTF">2020-08-13T07:23:49Z</dcterms:modified>
</cp:coreProperties>
</file>